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44113F-3A0C-4EED-9FF2-88DE051E9A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28E406-4175-414A-9FAB-9F0650740E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E22CFB-C6DC-4769-B97D-8E0E8C1BE6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2D10E0-4B1D-4232-9FBE-B00E0A408C6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CA38DC-A270-4A56-AE0C-BAE21806C8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3A118-5EEC-49C8-A6EF-1D3950FDB4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91A778-7649-48F7-90E7-5EC55B53E8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F414ED-7FB4-4CDF-ABC0-61E4E82841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83E9DD-3CA3-4987-9E69-82CEF786AD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C210D3-9AEA-433E-9E07-E324846F87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AF31F8-82CF-4526-8E76-445CA8D253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30D5D9-238D-45B4-BD02-0C547746FA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9DA5F4-3A0D-48A8-97FB-117253117183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1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fik 6" descr=""/>
          <p:cNvPicPr/>
          <p:nvPr/>
        </p:nvPicPr>
        <p:blipFill>
          <a:blip r:embed="rId1"/>
          <a:srcRect l="0" t="0" r="0" b="21227"/>
          <a:stretch/>
        </p:blipFill>
        <p:spPr>
          <a:xfrm>
            <a:off x="536400" y="679320"/>
            <a:ext cx="1947960" cy="354348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2" name=""/>
          <p:cNvGraphicFramePr/>
          <p:nvPr/>
        </p:nvGraphicFramePr>
        <p:xfrm>
          <a:off x="757080" y="4894200"/>
          <a:ext cx="10539720" cy="1758960"/>
        </p:xfrm>
        <a:graphic>
          <a:graphicData uri="http://schemas.openxmlformats.org/drawingml/2006/table">
            <a:tbl>
              <a:tblPr/>
              <a:tblGrid>
                <a:gridCol w="1462320"/>
                <a:gridCol w="426960"/>
                <a:gridCol w="452520"/>
                <a:gridCol w="446040"/>
                <a:gridCol w="417600"/>
                <a:gridCol w="390240"/>
                <a:gridCol w="382680"/>
                <a:gridCol w="390600"/>
                <a:gridCol w="419040"/>
                <a:gridCol w="420840"/>
                <a:gridCol w="390600"/>
                <a:gridCol w="425160"/>
                <a:gridCol w="409680"/>
                <a:gridCol w="487440"/>
                <a:gridCol w="542880"/>
                <a:gridCol w="514440"/>
                <a:gridCol w="382320"/>
                <a:gridCol w="470160"/>
                <a:gridCol w="434880"/>
                <a:gridCol w="409680"/>
                <a:gridCol w="419040"/>
                <a:gridCol w="444600"/>
              </a:tblGrid>
              <a:tr h="13356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9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1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4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4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4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4°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0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6°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332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D.HS-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D.HS-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D.HS-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A.31-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A.31-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A.31-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B.24-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B.24-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B.24-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D.24-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D.24-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D.24-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D.starv-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D.starv-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D.starv-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H.14-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H.14-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H.14-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B.6-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B.6-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B.6-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26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PATT000285690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75b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75b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2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273b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88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d385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37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1521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98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0d1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18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4334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9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23551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04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283d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1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b669d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9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36aa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9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970ac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0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16297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7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609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6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9669e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36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3f61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93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0e1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04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283d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24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172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15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182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89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126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PATT000291160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3bce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1e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bb7d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6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373b1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8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671a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1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c6ea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8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e6da8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0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c6ea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9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569a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99fd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1a4d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3a6d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da1d1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f97cb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ca0d1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7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e649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4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1476e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8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d5b8d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62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578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9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548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4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6446a"/>
                    </a:solidFill>
                  </a:tcPr>
                </a:tc>
              </a:tr>
              <a:tr h="1144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PATT000312170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9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84b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2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771ae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6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277b7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8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578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2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75f9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0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486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1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95d9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0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5f9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95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e527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7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b6eab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8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970ad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8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970ad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3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d649b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5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e649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1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8679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7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5f9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0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5456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68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568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11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507b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05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517d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5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4063"/>
                    </a:solidFill>
                  </a:tcPr>
                </a:tc>
              </a:tr>
              <a:tr h="1126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PATT000345030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b9e1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3a6d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6a8d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6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5d8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2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b5481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12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33451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48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33d5e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3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406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38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314b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6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174b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7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174b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75b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3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72b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8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473b1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3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273b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47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4b7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44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141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2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416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83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2a41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76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22b4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24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1724"/>
                    </a:solidFill>
                  </a:tcPr>
                </a:tc>
              </a:tr>
              <a:tr h="1141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PATT000354650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cb8e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bb7d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7b4dd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4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f6ca7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7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26aa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9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b5c8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9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e5b8d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8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b5d8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7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25989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490c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a5d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afd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9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585b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91c7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9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685b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1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548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07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a273c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6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c4a7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41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13e6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38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3e6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49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b2f49"/>
                    </a:solidFill>
                  </a:tcPr>
                </a:tc>
              </a:tr>
              <a:tr h="1126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PATT000182420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bce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1bbe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ab6d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3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373b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2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72b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7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6da9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5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6da9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1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96fac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7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870ad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5b2dc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4b2dc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4bde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1afd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4a6d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cacd8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0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c6ea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8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06ca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1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16ba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0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f6399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6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16298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2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95d90"/>
                    </a:solidFill>
                  </a:tcPr>
                </a:tc>
              </a:tr>
              <a:tr h="1126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PATT000334530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8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75b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6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671a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9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274b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8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4619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3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1598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16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34f7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91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d537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69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568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3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c4a7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1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c6ea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8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b6ea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9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b6ea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3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668a1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1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569a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2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668a1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7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f5a8b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00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74468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9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25888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1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c5c8e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7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05a8b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9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25888"/>
                    </a:solidFill>
                  </a:tcPr>
                </a:tc>
              </a:tr>
              <a:tr h="1144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PATT000102780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6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75b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7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6da9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3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075b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2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8679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3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5609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3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1598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6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3619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5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5609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9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4619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8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970ad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9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06ca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0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8679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0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95e91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4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5609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2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26197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8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f639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65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f487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1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4609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3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e649b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8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16298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4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06398"/>
                    </a:solidFill>
                  </a:tcPr>
                </a:tc>
              </a:tr>
              <a:tr h="1126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PATT000194200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3a5d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1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472b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9cce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6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870ad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c6ea9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7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c659c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5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6da9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0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e6da8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1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e6da8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2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771ae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1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c6ea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0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36aa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6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9669e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2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06399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5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9679e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6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6da9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5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69a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3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16ba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1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8679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6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69a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5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c659c"/>
                    </a:solidFill>
                  </a:tcPr>
                </a:tc>
              </a:tr>
              <a:tr h="1144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PATT000364200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1e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cacd8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faed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a3d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fbae1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b9e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bbe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5b3dc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c1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c2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7bfe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5bee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4bde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aad7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7a8d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4a6d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887c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3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a7dba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75b5"/>
                    </a:solidFill>
                  </a:tcPr>
                </a:tc>
              </a:tr>
              <a:tr h="1126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PATT000180660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c1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c0e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3bce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c0e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3bde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1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1e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c1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1e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4bde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1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c0e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c0e5"/>
                    </a:solidFill>
                  </a:tcPr>
                </a:tc>
              </a:tr>
              <a:tr h="1126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PATT000111150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7bfe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4bde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c0e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bbe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1bbe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7b4dd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a5d4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abd7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8b5de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1e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c0e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c2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1bbe2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4bde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5bee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0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283be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2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c7ebb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0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75b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0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283be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4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7ab8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8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75b5"/>
                    </a:solidFill>
                  </a:tcPr>
                </a:tc>
              </a:tr>
              <a:tr h="13320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PATT000115620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c2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7b4dd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4bde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4bde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8b4de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9b6de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b9e0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fbae1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c1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4bde3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1e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1e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c0e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4a6d5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5b2dc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acd8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7a8d6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.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098cb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b94c9"/>
                    </a:solidFill>
                  </a:tcPr>
                </a:tc>
              </a:tr>
            </a:tbl>
          </a:graphicData>
        </a:graphic>
      </p:graphicFrame>
      <p:pic>
        <p:nvPicPr>
          <p:cNvPr id="43" name="Grafik 15" descr=""/>
          <p:cNvPicPr/>
          <p:nvPr/>
        </p:nvPicPr>
        <p:blipFill>
          <a:blip r:embed="rId2"/>
          <a:stretch/>
        </p:blipFill>
        <p:spPr>
          <a:xfrm>
            <a:off x="4927680" y="816120"/>
            <a:ext cx="5049720" cy="3344760"/>
          </a:xfrm>
          <a:prstGeom prst="rect">
            <a:avLst/>
          </a:prstGeom>
          <a:ln w="0">
            <a:noFill/>
          </a:ln>
        </p:spPr>
      </p:pic>
      <p:sp>
        <p:nvSpPr>
          <p:cNvPr id="44" name="Geschweifte Klammer rechts 2"/>
          <p:cNvSpPr/>
          <p:nvPr/>
        </p:nvSpPr>
        <p:spPr>
          <a:xfrm>
            <a:off x="9864720" y="2852640"/>
            <a:ext cx="363600" cy="884160"/>
          </a:xfrm>
          <a:custGeom>
            <a:avLst/>
            <a:gdLst>
              <a:gd name="textAreaLeft" fmla="*/ 0 w 363600"/>
              <a:gd name="textAreaRight" fmla="*/ 131400 w 363600"/>
              <a:gd name="textAreaTop" fmla="*/ 9360 h 884160"/>
              <a:gd name="textAreaBottom" fmla="*/ 874800 h 8841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370"/>
                  <a:pt x="10800" y="740"/>
                </a:cubicBezTo>
                <a:lnTo>
                  <a:pt x="10800" y="10060"/>
                </a:lnTo>
                <a:cubicBezTo>
                  <a:pt x="10800" y="10430"/>
                  <a:pt x="16200" y="10800"/>
                  <a:pt x="21600" y="10800"/>
                </a:cubicBezTo>
                <a:cubicBezTo>
                  <a:pt x="16200" y="10800"/>
                  <a:pt x="10800" y="11170"/>
                  <a:pt x="10800" y="11540"/>
                </a:cubicBezTo>
                <a:lnTo>
                  <a:pt x="10800" y="20860"/>
                </a:lnTo>
                <a:cubicBezTo>
                  <a:pt x="10800" y="21230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feld 4"/>
          <p:cNvSpPr/>
          <p:nvPr/>
        </p:nvSpPr>
        <p:spPr>
          <a:xfrm>
            <a:off x="10233000" y="2936880"/>
            <a:ext cx="1368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upregulated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in autogamy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Grafik 10" descr=""/>
          <p:cNvPicPr/>
          <p:nvPr/>
        </p:nvPicPr>
        <p:blipFill>
          <a:blip r:embed="rId3"/>
          <a:srcRect l="0" t="82841" r="0" b="-313"/>
          <a:stretch/>
        </p:blipFill>
        <p:spPr>
          <a:xfrm>
            <a:off x="3011400" y="679320"/>
            <a:ext cx="1947960" cy="785880"/>
          </a:xfrm>
          <a:prstGeom prst="rect">
            <a:avLst/>
          </a:prstGeom>
          <a:ln w="0">
            <a:noFill/>
          </a:ln>
        </p:spPr>
      </p:pic>
      <p:sp>
        <p:nvSpPr>
          <p:cNvPr id="47" name="Textfeld 11"/>
          <p:cNvSpPr/>
          <p:nvPr/>
        </p:nvSpPr>
        <p:spPr>
          <a:xfrm>
            <a:off x="343800" y="263520"/>
            <a:ext cx="24652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alibri"/>
              </a:rPr>
              <a:t>Downregulated chromatin associated genes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alibri"/>
              </a:rPr>
              <a:t>in B.24 vs. D.24 comparis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feld 12"/>
          <p:cNvSpPr/>
          <p:nvPr/>
        </p:nvSpPr>
        <p:spPr>
          <a:xfrm>
            <a:off x="2842200" y="263520"/>
            <a:ext cx="23112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alibri"/>
              </a:rPr>
              <a:t>Upregulated chromatin associated genes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alibri"/>
              </a:rPr>
              <a:t>in B.24 vs. D.24 comparis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feld 13"/>
          <p:cNvSpPr/>
          <p:nvPr/>
        </p:nvSpPr>
        <p:spPr>
          <a:xfrm>
            <a:off x="13320" y="3816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feld 14"/>
          <p:cNvSpPr/>
          <p:nvPr/>
        </p:nvSpPr>
        <p:spPr>
          <a:xfrm>
            <a:off x="4933440" y="194796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feld 15"/>
          <p:cNvSpPr/>
          <p:nvPr/>
        </p:nvSpPr>
        <p:spPr>
          <a:xfrm>
            <a:off x="758160" y="445464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3-02T17:40:02Z</dcterms:created>
  <dc:creator>Admin</dc:creator>
  <dc:description/>
  <dc:language>en-US</dc:language>
  <cp:lastModifiedBy>Martin</cp:lastModifiedBy>
  <cp:lastPrinted>2015-03-17T18:20:49Z</cp:lastPrinted>
  <dcterms:modified xsi:type="dcterms:W3CDTF">2015-06-13T17:46:38Z</dcterms:modified>
  <cp:revision>6</cp:revision>
  <dc:subject/>
  <dc:title>PowerPoint-Präsentation</dc:title>
</cp:coreProperties>
</file>